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7" r:id="rId2"/>
    <p:sldId id="260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731"/>
  </p:normalViewPr>
  <p:slideViewPr>
    <p:cSldViewPr snapToGrid="0" snapToObjects="1">
      <p:cViewPr varScale="1">
        <p:scale>
          <a:sx n="109" d="100"/>
          <a:sy n="109" d="100"/>
        </p:scale>
        <p:origin x="636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604BA9-E76C-664A-9E11-65DD58F97E6D}" type="datetimeFigureOut">
              <a:rPr kumimoji="1" lang="zh-CN" altLang="en-US" smtClean="0"/>
              <a:t>2022/2/20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99E1F13-6070-6840-A47F-1B09A86C8F0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226595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99E1F13-6070-6840-A47F-1B09A86C8F0F}" type="slidenum">
              <a:rPr kumimoji="1" lang="zh-CN" altLang="en-US" smtClean="0"/>
              <a:t>2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061763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F96CAFC-2F4D-DA45-9A07-4344C3EF2C3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07A70E4-4F62-134D-A549-523E1963D37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156C72F-43E1-5444-A097-417ADC3E84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63F012-5022-FC42-BDC0-80F8EDA06B50}" type="datetimeFigureOut">
              <a:rPr kumimoji="1" lang="zh-CN" altLang="en-US" smtClean="0"/>
              <a:t>2022/2/2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979F429-C621-7940-9DAF-BF5826C08B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B9843B8-DB1B-B94B-A7F6-1090B3A42F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A06F4-A0EE-4540-8902-8F2BE0971AD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494426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B9BE0CA-BEA9-9244-9A3D-7644634698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8D96357-1F08-2D48-B68F-503E720A3D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315506C-AD42-4E48-A4B6-C25D5B4F37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63F012-5022-FC42-BDC0-80F8EDA06B50}" type="datetimeFigureOut">
              <a:rPr kumimoji="1" lang="zh-CN" altLang="en-US" smtClean="0"/>
              <a:t>2022/2/2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F25C765-9161-AD49-90E0-69E7B58C93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C3D5DCC-A8AF-1547-BF55-AA4644DA69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A06F4-A0EE-4540-8902-8F2BE0971AD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3431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E1CF76A-0D9D-2F4B-8FE8-ABF3EB5D711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8DBF419-89E1-354B-8E2A-1DB1E3AF60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B068A04-64B1-7C42-AB8B-B59F881860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63F012-5022-FC42-BDC0-80F8EDA06B50}" type="datetimeFigureOut">
              <a:rPr kumimoji="1" lang="zh-CN" altLang="en-US" smtClean="0"/>
              <a:t>2022/2/2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BC0F35A-9687-6946-A932-310147CA16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F03734B-3F47-0344-B3C9-28C1F459AA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A06F4-A0EE-4540-8902-8F2BE0971AD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377684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31AD70-7579-3B4F-B066-7B7C35D663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9CB0238-6DD4-3C46-BAC2-69A17590BD3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315FAEB-1B01-D847-9C8D-7C8E1C1663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63F012-5022-FC42-BDC0-80F8EDA06B50}" type="datetimeFigureOut">
              <a:rPr kumimoji="1" lang="zh-CN" altLang="en-US" smtClean="0"/>
              <a:t>2022/2/2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A9ED19D-EF71-964E-BD4A-B4FCB735C9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3B09820-BCE7-5C47-962D-9BBC58F584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A06F4-A0EE-4540-8902-8F2BE0971AD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59108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2AF8C43-A3D2-8B4B-8229-49C8E07856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6DF76AA-3373-724F-82F7-BAD0B42657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68EA05-E278-4848-AB0E-CC472434DF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63F012-5022-FC42-BDC0-80F8EDA06B50}" type="datetimeFigureOut">
              <a:rPr kumimoji="1" lang="zh-CN" altLang="en-US" smtClean="0"/>
              <a:t>2022/2/2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12CECD7-6153-404B-AD46-7A2F6D92A3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C33CADA-10A3-D143-80AB-2B94154AED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A06F4-A0EE-4540-8902-8F2BE0971AD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983932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4C61827-9D84-2D4D-B5EC-3D0C2DC854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8FF6A5F-41CB-6A41-9996-61F8B6DC0E3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A479A3C-20FF-5749-B02A-0AFFC2EB4C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034218C-D22B-8E4A-AC62-B10143248B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63F012-5022-FC42-BDC0-80F8EDA06B50}" type="datetimeFigureOut">
              <a:rPr kumimoji="1" lang="zh-CN" altLang="en-US" smtClean="0"/>
              <a:t>2022/2/20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2F09B1C-309D-8F4D-AFF9-3B7FAFD28C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14BFF45-1186-2943-86D0-7111511C5E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A06F4-A0EE-4540-8902-8F2BE0971AD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481676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34B0F93-CC66-9D4A-A016-9DC3F1C1AD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FFEA536-32D6-924C-BC78-2B887B6EE7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EF23511-8EC0-924A-A4F2-3FC5C8014C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697370F6-0145-E545-BF74-41603BB886F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8F08455-E886-AF42-8A4A-134233047C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69BFF25-9C5C-9940-95C7-BD10152362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63F012-5022-FC42-BDC0-80F8EDA06B50}" type="datetimeFigureOut">
              <a:rPr kumimoji="1" lang="zh-CN" altLang="en-US" smtClean="0"/>
              <a:t>2022/2/20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0B04B78-CB96-F04C-8267-F2FFF6A9B8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6CFD7E2-5815-714B-AEDD-62180660F2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A06F4-A0EE-4540-8902-8F2BE0971AD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9672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B9CFC2D-9A7B-E54C-96CC-24DBD88AF1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2678675-7180-2B4B-BA59-74C4CE52EA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63F012-5022-FC42-BDC0-80F8EDA06B50}" type="datetimeFigureOut">
              <a:rPr kumimoji="1" lang="zh-CN" altLang="en-US" smtClean="0"/>
              <a:t>2022/2/20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D229564-1819-7445-A0A2-19582A2408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03DAEF1-FA26-B349-9083-A51CF8C9D5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A06F4-A0EE-4540-8902-8F2BE0971AD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533318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9724873-2BA0-8D46-A556-0681F1BCF1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63F012-5022-FC42-BDC0-80F8EDA06B50}" type="datetimeFigureOut">
              <a:rPr kumimoji="1" lang="zh-CN" altLang="en-US" smtClean="0"/>
              <a:t>2022/2/20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CEBC44A-BA1C-5546-AC40-4F7DCAEF12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2D92047-7B6B-154F-9843-267B13540E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A06F4-A0EE-4540-8902-8F2BE0971AD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102472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58ED504-B6B5-BD41-B35C-64CA36A404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1010CF1-A353-BA45-8CFF-C40DF775049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E4697EA-83AD-B74C-B809-E4147EDAD8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7E6158C-D0F5-8E46-ADFD-104F098D53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63F012-5022-FC42-BDC0-80F8EDA06B50}" type="datetimeFigureOut">
              <a:rPr kumimoji="1" lang="zh-CN" altLang="en-US" smtClean="0"/>
              <a:t>2022/2/20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21893F3-A146-AF47-B3AF-558A55F9DD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84BC896-C0E0-6046-BEDB-D9D82637B0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A06F4-A0EE-4540-8902-8F2BE0971AD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282552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32E641B-E0F4-754E-A4C8-06A443CAA5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4A67FA0-880C-514B-A6C0-570D9C4294B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70A488E-4ED7-3A4A-AEE1-C81216BBFD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CDBC7A5-E38F-D54C-B33F-215FE53D56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63F012-5022-FC42-BDC0-80F8EDA06B50}" type="datetimeFigureOut">
              <a:rPr kumimoji="1" lang="zh-CN" altLang="en-US" smtClean="0"/>
              <a:t>2022/2/20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22B032C-6E3E-B04D-87AC-099530605D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9E67A3B-6183-E047-B263-D64D6483F1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A06F4-A0EE-4540-8902-8F2BE0971AD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39470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6CEB2EE-A43C-EF44-985A-05B421C9F0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473C559-A7A0-2942-9A61-9F722D9842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9385A86-446B-3349-837C-E56B79243BD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63F012-5022-FC42-BDC0-80F8EDA06B50}" type="datetimeFigureOut">
              <a:rPr kumimoji="1" lang="zh-CN" altLang="en-US" smtClean="0"/>
              <a:t>2022/2/2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9554E56-0E4A-9948-AEB7-7A7EE6485D4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9E746BC-CBD6-0D43-A15B-46F3B54065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5A06F4-A0EE-4540-8902-8F2BE0971AD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962853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2" name="组合 61">
            <a:extLst>
              <a:ext uri="{FF2B5EF4-FFF2-40B4-BE49-F238E27FC236}">
                <a16:creationId xmlns:a16="http://schemas.microsoft.com/office/drawing/2014/main" id="{3F10172E-B3D1-6446-B216-73D83B904407}"/>
              </a:ext>
            </a:extLst>
          </p:cNvPr>
          <p:cNvGrpSpPr/>
          <p:nvPr/>
        </p:nvGrpSpPr>
        <p:grpSpPr>
          <a:xfrm>
            <a:off x="6102044" y="1887693"/>
            <a:ext cx="1844756" cy="3013160"/>
            <a:chOff x="6090614" y="1887693"/>
            <a:chExt cx="1844756" cy="3013160"/>
          </a:xfrm>
        </p:grpSpPr>
        <p:sp>
          <p:nvSpPr>
            <p:cNvPr id="2" name="椭圆 1">
              <a:extLst>
                <a:ext uri="{FF2B5EF4-FFF2-40B4-BE49-F238E27FC236}">
                  <a16:creationId xmlns:a16="http://schemas.microsoft.com/office/drawing/2014/main" id="{C8423505-7404-6A4A-86B3-BF5F710046C6}"/>
                </a:ext>
              </a:extLst>
            </p:cNvPr>
            <p:cNvSpPr/>
            <p:nvPr/>
          </p:nvSpPr>
          <p:spPr>
            <a:xfrm>
              <a:off x="6201002" y="1887693"/>
              <a:ext cx="565614" cy="553765"/>
            </a:xfrm>
            <a:prstGeom prst="ellipse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椭圆 5">
              <a:extLst>
                <a:ext uri="{FF2B5EF4-FFF2-40B4-BE49-F238E27FC236}">
                  <a16:creationId xmlns:a16="http://schemas.microsoft.com/office/drawing/2014/main" id="{217B7AF7-D634-1D45-8028-434244AB9916}"/>
                </a:ext>
              </a:extLst>
            </p:cNvPr>
            <p:cNvSpPr/>
            <p:nvPr/>
          </p:nvSpPr>
          <p:spPr>
            <a:xfrm>
              <a:off x="7369756" y="2467026"/>
              <a:ext cx="565614" cy="553765"/>
            </a:xfrm>
            <a:prstGeom prst="ellipse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椭圆 7">
              <a:extLst>
                <a:ext uri="{FF2B5EF4-FFF2-40B4-BE49-F238E27FC236}">
                  <a16:creationId xmlns:a16="http://schemas.microsoft.com/office/drawing/2014/main" id="{FEF98E1D-F439-CE4F-AE4B-546BF0918E1C}"/>
                </a:ext>
              </a:extLst>
            </p:cNvPr>
            <p:cNvSpPr/>
            <p:nvPr/>
          </p:nvSpPr>
          <p:spPr>
            <a:xfrm>
              <a:off x="6797004" y="2176956"/>
              <a:ext cx="541201" cy="553765"/>
            </a:xfrm>
            <a:prstGeom prst="ellipse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椭圆 8">
              <a:extLst>
                <a:ext uri="{FF2B5EF4-FFF2-40B4-BE49-F238E27FC236}">
                  <a16:creationId xmlns:a16="http://schemas.microsoft.com/office/drawing/2014/main" id="{47E20345-7027-9441-9F5B-72BD1AB95028}"/>
                </a:ext>
              </a:extLst>
            </p:cNvPr>
            <p:cNvSpPr/>
            <p:nvPr/>
          </p:nvSpPr>
          <p:spPr>
            <a:xfrm>
              <a:off x="6327913" y="3472127"/>
              <a:ext cx="297336" cy="283294"/>
            </a:xfrm>
            <a:prstGeom prst="ellipse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椭圆 9">
              <a:extLst>
                <a:ext uri="{FF2B5EF4-FFF2-40B4-BE49-F238E27FC236}">
                  <a16:creationId xmlns:a16="http://schemas.microsoft.com/office/drawing/2014/main" id="{C9B4AB50-3BF1-2E4F-95AF-554F62ED7486}"/>
                </a:ext>
              </a:extLst>
            </p:cNvPr>
            <p:cNvSpPr/>
            <p:nvPr/>
          </p:nvSpPr>
          <p:spPr>
            <a:xfrm>
              <a:off x="6335141" y="3762885"/>
              <a:ext cx="297336" cy="283294"/>
            </a:xfrm>
            <a:prstGeom prst="ellipse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椭圆 10">
              <a:extLst>
                <a:ext uri="{FF2B5EF4-FFF2-40B4-BE49-F238E27FC236}">
                  <a16:creationId xmlns:a16="http://schemas.microsoft.com/office/drawing/2014/main" id="{83D9DDD1-7AC8-4849-8FD2-A4760B32CB8D}"/>
                </a:ext>
              </a:extLst>
            </p:cNvPr>
            <p:cNvSpPr/>
            <p:nvPr/>
          </p:nvSpPr>
          <p:spPr>
            <a:xfrm>
              <a:off x="6912708" y="4050218"/>
              <a:ext cx="297336" cy="283294"/>
            </a:xfrm>
            <a:prstGeom prst="ellipse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椭圆 11">
              <a:extLst>
                <a:ext uri="{FF2B5EF4-FFF2-40B4-BE49-F238E27FC236}">
                  <a16:creationId xmlns:a16="http://schemas.microsoft.com/office/drawing/2014/main" id="{9255D8EF-173C-1942-BBFD-C2FC132EEAAA}"/>
                </a:ext>
              </a:extLst>
            </p:cNvPr>
            <p:cNvSpPr/>
            <p:nvPr/>
          </p:nvSpPr>
          <p:spPr>
            <a:xfrm>
              <a:off x="7503895" y="4053643"/>
              <a:ext cx="297336" cy="283294"/>
            </a:xfrm>
            <a:prstGeom prst="ellipse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椭圆 12">
              <a:extLst>
                <a:ext uri="{FF2B5EF4-FFF2-40B4-BE49-F238E27FC236}">
                  <a16:creationId xmlns:a16="http://schemas.microsoft.com/office/drawing/2014/main" id="{F5135F7E-20C6-8946-AFE0-B48D2D2B41CE}"/>
                </a:ext>
              </a:extLst>
            </p:cNvPr>
            <p:cNvSpPr/>
            <p:nvPr/>
          </p:nvSpPr>
          <p:spPr>
            <a:xfrm>
              <a:off x="7503895" y="3762885"/>
              <a:ext cx="297336" cy="283294"/>
            </a:xfrm>
            <a:prstGeom prst="ellipse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椭圆 13">
              <a:extLst>
                <a:ext uri="{FF2B5EF4-FFF2-40B4-BE49-F238E27FC236}">
                  <a16:creationId xmlns:a16="http://schemas.microsoft.com/office/drawing/2014/main" id="{963E92B9-C3D2-9048-AE40-88A960BB21D9}"/>
                </a:ext>
              </a:extLst>
            </p:cNvPr>
            <p:cNvSpPr/>
            <p:nvPr/>
          </p:nvSpPr>
          <p:spPr>
            <a:xfrm>
              <a:off x="6918894" y="3472127"/>
              <a:ext cx="297336" cy="283294"/>
            </a:xfrm>
            <a:prstGeom prst="ellipse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椭圆 14">
              <a:extLst>
                <a:ext uri="{FF2B5EF4-FFF2-40B4-BE49-F238E27FC236}">
                  <a16:creationId xmlns:a16="http://schemas.microsoft.com/office/drawing/2014/main" id="{7D04EA72-983C-0A42-A144-9C836CA32697}"/>
                </a:ext>
              </a:extLst>
            </p:cNvPr>
            <p:cNvSpPr/>
            <p:nvPr/>
          </p:nvSpPr>
          <p:spPr>
            <a:xfrm>
              <a:off x="6376238" y="4671604"/>
              <a:ext cx="211562" cy="201571"/>
            </a:xfrm>
            <a:prstGeom prst="ellipse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椭圆 15">
              <a:extLst>
                <a:ext uri="{FF2B5EF4-FFF2-40B4-BE49-F238E27FC236}">
                  <a16:creationId xmlns:a16="http://schemas.microsoft.com/office/drawing/2014/main" id="{02860162-5564-3441-8FE8-25269AE0A205}"/>
                </a:ext>
              </a:extLst>
            </p:cNvPr>
            <p:cNvSpPr/>
            <p:nvPr/>
          </p:nvSpPr>
          <p:spPr>
            <a:xfrm>
              <a:off x="6955595" y="4671603"/>
              <a:ext cx="211562" cy="201571"/>
            </a:xfrm>
            <a:prstGeom prst="ellipse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椭圆 16">
              <a:extLst>
                <a:ext uri="{FF2B5EF4-FFF2-40B4-BE49-F238E27FC236}">
                  <a16:creationId xmlns:a16="http://schemas.microsoft.com/office/drawing/2014/main" id="{2D4E2098-C0A8-314B-A036-DE5F97A16774}"/>
                </a:ext>
              </a:extLst>
            </p:cNvPr>
            <p:cNvSpPr/>
            <p:nvPr/>
          </p:nvSpPr>
          <p:spPr>
            <a:xfrm>
              <a:off x="7546782" y="4671603"/>
              <a:ext cx="211562" cy="201571"/>
            </a:xfrm>
            <a:prstGeom prst="ellipse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矩形 42">
              <a:extLst>
                <a:ext uri="{FF2B5EF4-FFF2-40B4-BE49-F238E27FC236}">
                  <a16:creationId xmlns:a16="http://schemas.microsoft.com/office/drawing/2014/main" id="{6B625273-C1E5-8C40-803F-8D3B4C19EB32}"/>
                </a:ext>
              </a:extLst>
            </p:cNvPr>
            <p:cNvSpPr/>
            <p:nvPr/>
          </p:nvSpPr>
          <p:spPr>
            <a:xfrm>
              <a:off x="6090614" y="4654632"/>
              <a:ext cx="178766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</a:t>
              </a:r>
              <a:r>
                <a:rPr kumimoji="1"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3.4</a:t>
              </a:r>
              <a:r>
                <a:rPr kumimoji="1"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 </a:t>
              </a:r>
              <a:r>
                <a:rPr kumimoji="1"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3.3</a:t>
              </a:r>
              <a:r>
                <a:rPr kumimoji="1"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 </a:t>
              </a:r>
              <a:r>
                <a:rPr kumimoji="1"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3.4</a:t>
              </a: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F198CF53-A50B-4349-9DA1-8591E70248FD}"/>
                </a:ext>
              </a:extLst>
            </p:cNvPr>
            <p:cNvSpPr txBox="1"/>
            <p:nvPr/>
          </p:nvSpPr>
          <p:spPr>
            <a:xfrm>
              <a:off x="7560400" y="3430839"/>
              <a:ext cx="2535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600" dirty="0">
                  <a:solidFill>
                    <a:schemeClr val="bg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·</a:t>
              </a:r>
              <a:endParaRPr kumimoji="1" lang="zh-CN" altLang="en-US" sz="1600" dirty="0">
                <a:solidFill>
                  <a:schemeClr val="bg2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C859DD28-3670-0844-8C69-0D49A7D71171}"/>
                </a:ext>
              </a:extLst>
            </p:cNvPr>
            <p:cNvSpPr txBox="1"/>
            <p:nvPr/>
          </p:nvSpPr>
          <p:spPr>
            <a:xfrm>
              <a:off x="6369034" y="4009978"/>
              <a:ext cx="2535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600" dirty="0">
                  <a:solidFill>
                    <a:schemeClr val="bg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·</a:t>
              </a:r>
              <a:endParaRPr kumimoji="1" lang="zh-CN" altLang="en-US" sz="1600" dirty="0">
                <a:solidFill>
                  <a:schemeClr val="bg2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" name="文本框 4">
            <a:extLst>
              <a:ext uri="{FF2B5EF4-FFF2-40B4-BE49-F238E27FC236}">
                <a16:creationId xmlns:a16="http://schemas.microsoft.com/office/drawing/2014/main" id="{6F71F877-6B13-084D-88AD-A5A7B70F75A1}"/>
              </a:ext>
            </a:extLst>
          </p:cNvPr>
          <p:cNvSpPr txBox="1"/>
          <p:nvPr/>
        </p:nvSpPr>
        <p:spPr>
          <a:xfrm>
            <a:off x="5939562" y="872409"/>
            <a:ext cx="22577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rect comparisons in the network</a:t>
            </a:r>
            <a:endParaRPr kumimoji="1"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直线连接符 19">
            <a:extLst>
              <a:ext uri="{FF2B5EF4-FFF2-40B4-BE49-F238E27FC236}">
                <a16:creationId xmlns:a16="http://schemas.microsoft.com/office/drawing/2014/main" id="{7727FD59-46C7-5841-B5ED-34B8A959F945}"/>
              </a:ext>
            </a:extLst>
          </p:cNvPr>
          <p:cNvCxnSpPr>
            <a:cxnSpLocks/>
          </p:cNvCxnSpPr>
          <p:nvPr/>
        </p:nvCxnSpPr>
        <p:spPr>
          <a:xfrm>
            <a:off x="5895163" y="778873"/>
            <a:ext cx="0" cy="458680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52FE4A5F-496E-1B44-9A3D-CEDA79E94312}"/>
              </a:ext>
            </a:extLst>
          </p:cNvPr>
          <p:cNvSpPr txBox="1"/>
          <p:nvPr/>
        </p:nvSpPr>
        <p:spPr>
          <a:xfrm>
            <a:off x="4259544" y="4580574"/>
            <a:ext cx="1136850" cy="3411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tire network</a:t>
            </a: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00B8E60F-AD65-6648-B564-028A6250FC05}"/>
              </a:ext>
            </a:extLst>
          </p:cNvPr>
          <p:cNvSpPr txBox="1"/>
          <p:nvPr/>
        </p:nvSpPr>
        <p:spPr>
          <a:xfrm>
            <a:off x="4385676" y="3137935"/>
            <a:ext cx="11769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rect estimates</a:t>
            </a:r>
            <a:endParaRPr kumimoji="1"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3528AA92-7030-B04F-A58D-FE9C05A7702D}"/>
              </a:ext>
            </a:extLst>
          </p:cNvPr>
          <p:cNvSpPr/>
          <p:nvPr/>
        </p:nvSpPr>
        <p:spPr>
          <a:xfrm>
            <a:off x="4385676" y="1764824"/>
            <a:ext cx="110799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xed estimates</a:t>
            </a: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39C3B1B8-2F2B-254B-9198-3EDC0D0A840A}"/>
              </a:ext>
            </a:extLst>
          </p:cNvPr>
          <p:cNvSpPr txBox="1"/>
          <p:nvPr/>
        </p:nvSpPr>
        <p:spPr>
          <a:xfrm rot="16200000">
            <a:off x="2903301" y="2837969"/>
            <a:ext cx="22252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twork</a:t>
            </a:r>
            <a:r>
              <a:rPr kumimoji="1"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-analysis</a:t>
            </a:r>
            <a:r>
              <a:rPr kumimoji="1"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timates</a:t>
            </a:r>
            <a:endParaRPr kumimoji="1"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9B8D346D-09AB-774A-9C51-623CB6E6905B}"/>
              </a:ext>
            </a:extLst>
          </p:cNvPr>
          <p:cNvSpPr/>
          <p:nvPr/>
        </p:nvSpPr>
        <p:spPr>
          <a:xfrm>
            <a:off x="5181646" y="2031100"/>
            <a:ext cx="154721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vsB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.0</a:t>
            </a: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5A7BB694-9ACB-7F46-845C-78AC69241F9E}"/>
              </a:ext>
            </a:extLst>
          </p:cNvPr>
          <p:cNvSpPr/>
          <p:nvPr/>
        </p:nvSpPr>
        <p:spPr>
          <a:xfrm>
            <a:off x="5181646" y="2316850"/>
            <a:ext cx="27430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vsC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9.7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934CB094-A7EF-8D4E-A610-DEA14FEDD4EC}"/>
              </a:ext>
            </a:extLst>
          </p:cNvPr>
          <p:cNvSpPr/>
          <p:nvPr/>
        </p:nvSpPr>
        <p:spPr>
          <a:xfrm>
            <a:off x="5181645" y="2602600"/>
            <a:ext cx="27430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vsD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.0</a:t>
            </a: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8F553B5A-BE2A-A744-BB56-4A6E5C08883A}"/>
              </a:ext>
            </a:extLst>
          </p:cNvPr>
          <p:cNvSpPr/>
          <p:nvPr/>
        </p:nvSpPr>
        <p:spPr>
          <a:xfrm>
            <a:off x="6247534" y="1165148"/>
            <a:ext cx="164179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vsB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</a:t>
            </a:r>
            <a:r>
              <a:rPr kumimoji="1"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vsC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</a:t>
            </a:r>
            <a:r>
              <a:rPr kumimoji="1"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vsD</a:t>
            </a:r>
            <a:endParaRPr kumimoji="1"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线连接符 35">
            <a:extLst>
              <a:ext uri="{FF2B5EF4-FFF2-40B4-BE49-F238E27FC236}">
                <a16:creationId xmlns:a16="http://schemas.microsoft.com/office/drawing/2014/main" id="{81D98614-3AC6-7246-9B05-840F7B319EEF}"/>
              </a:ext>
            </a:extLst>
          </p:cNvPr>
          <p:cNvCxnSpPr>
            <a:cxnSpLocks/>
          </p:cNvCxnSpPr>
          <p:nvPr/>
        </p:nvCxnSpPr>
        <p:spPr>
          <a:xfrm>
            <a:off x="4193154" y="3008515"/>
            <a:ext cx="3894286" cy="762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矩形 38">
            <a:extLst>
              <a:ext uri="{FF2B5EF4-FFF2-40B4-BE49-F238E27FC236}">
                <a16:creationId xmlns:a16="http://schemas.microsoft.com/office/drawing/2014/main" id="{5C00A8B6-B3D4-3242-82FA-985E4E38A81B}"/>
              </a:ext>
            </a:extLst>
          </p:cNvPr>
          <p:cNvSpPr/>
          <p:nvPr/>
        </p:nvSpPr>
        <p:spPr>
          <a:xfrm>
            <a:off x="5181645" y="3772354"/>
            <a:ext cx="267893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vsC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id="{7FA9D7A7-4263-E945-9600-A69F85941C9D}"/>
              </a:ext>
            </a:extLst>
          </p:cNvPr>
          <p:cNvSpPr/>
          <p:nvPr/>
        </p:nvSpPr>
        <p:spPr>
          <a:xfrm>
            <a:off x="5179401" y="4066767"/>
            <a:ext cx="271099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vsD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9.9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.0</a:t>
            </a:r>
          </a:p>
        </p:txBody>
      </p:sp>
      <p:sp>
        <p:nvSpPr>
          <p:cNvPr id="41" name="矩形 40">
            <a:extLst>
              <a:ext uri="{FF2B5EF4-FFF2-40B4-BE49-F238E27FC236}">
                <a16:creationId xmlns:a16="http://schemas.microsoft.com/office/drawing/2014/main" id="{AE040610-9F41-5F40-94C8-6D78B55B7A0E}"/>
              </a:ext>
            </a:extLst>
          </p:cNvPr>
          <p:cNvSpPr/>
          <p:nvPr/>
        </p:nvSpPr>
        <p:spPr>
          <a:xfrm>
            <a:off x="5181644" y="3492089"/>
            <a:ext cx="26853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vsC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.0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9.9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</a:t>
            </a:r>
          </a:p>
        </p:txBody>
      </p:sp>
      <p:sp>
        <p:nvSpPr>
          <p:cNvPr id="44" name="矩形 43">
            <a:extLst>
              <a:ext uri="{FF2B5EF4-FFF2-40B4-BE49-F238E27FC236}">
                <a16:creationId xmlns:a16="http://schemas.microsoft.com/office/drawing/2014/main" id="{CFF3F092-9C14-004B-9E78-24002F7CFAB0}"/>
              </a:ext>
            </a:extLst>
          </p:cNvPr>
          <p:cNvSpPr/>
          <p:nvPr/>
        </p:nvSpPr>
        <p:spPr>
          <a:xfrm>
            <a:off x="6091784" y="5102493"/>
            <a:ext cx="162736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4" name="组合 53">
            <a:extLst>
              <a:ext uri="{FF2B5EF4-FFF2-40B4-BE49-F238E27FC236}">
                <a16:creationId xmlns:a16="http://schemas.microsoft.com/office/drawing/2014/main" id="{4A10111D-096E-DA40-8154-349A58B307ED}"/>
              </a:ext>
            </a:extLst>
          </p:cNvPr>
          <p:cNvGrpSpPr/>
          <p:nvPr/>
        </p:nvGrpSpPr>
        <p:grpSpPr>
          <a:xfrm>
            <a:off x="3860800" y="1571105"/>
            <a:ext cx="4511554" cy="3445946"/>
            <a:chOff x="3333404" y="1571105"/>
            <a:chExt cx="4807038" cy="3445946"/>
          </a:xfrm>
        </p:grpSpPr>
        <p:cxnSp>
          <p:nvCxnSpPr>
            <p:cNvPr id="22" name="直线连接符 21">
              <a:extLst>
                <a:ext uri="{FF2B5EF4-FFF2-40B4-BE49-F238E27FC236}">
                  <a16:creationId xmlns:a16="http://schemas.microsoft.com/office/drawing/2014/main" id="{67399949-CC41-3441-AB92-66AF782ACE99}"/>
                </a:ext>
              </a:extLst>
            </p:cNvPr>
            <p:cNvCxnSpPr>
              <a:cxnSpLocks/>
            </p:cNvCxnSpPr>
            <p:nvPr/>
          </p:nvCxnSpPr>
          <p:spPr>
            <a:xfrm>
              <a:off x="3333404" y="1571105"/>
              <a:ext cx="479228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" name="直线连接符 47">
              <a:extLst>
                <a:ext uri="{FF2B5EF4-FFF2-40B4-BE49-F238E27FC236}">
                  <a16:creationId xmlns:a16="http://schemas.microsoft.com/office/drawing/2014/main" id="{151E70A3-7832-2D4B-AF6C-D64D0DF9D48C}"/>
                </a:ext>
              </a:extLst>
            </p:cNvPr>
            <p:cNvCxnSpPr>
              <a:cxnSpLocks/>
            </p:cNvCxnSpPr>
            <p:nvPr/>
          </p:nvCxnSpPr>
          <p:spPr>
            <a:xfrm>
              <a:off x="3348155" y="4508269"/>
              <a:ext cx="479228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9" name="直线连接符 48">
              <a:extLst>
                <a:ext uri="{FF2B5EF4-FFF2-40B4-BE49-F238E27FC236}">
                  <a16:creationId xmlns:a16="http://schemas.microsoft.com/office/drawing/2014/main" id="{1A019ED1-C963-7A4C-BAE5-EED160F6BBDA}"/>
                </a:ext>
              </a:extLst>
            </p:cNvPr>
            <p:cNvCxnSpPr>
              <a:cxnSpLocks/>
            </p:cNvCxnSpPr>
            <p:nvPr/>
          </p:nvCxnSpPr>
          <p:spPr>
            <a:xfrm>
              <a:off x="3348154" y="5017051"/>
              <a:ext cx="479228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0" name="矩形 49">
            <a:extLst>
              <a:ext uri="{FF2B5EF4-FFF2-40B4-BE49-F238E27FC236}">
                <a16:creationId xmlns:a16="http://schemas.microsoft.com/office/drawing/2014/main" id="{C72509A2-B375-BA4C-B0F2-CA2EFFEEB468}"/>
              </a:ext>
            </a:extLst>
          </p:cNvPr>
          <p:cNvSpPr/>
          <p:nvPr/>
        </p:nvSpPr>
        <p:spPr>
          <a:xfrm>
            <a:off x="4201836" y="5024191"/>
            <a:ext cx="1191352" cy="3361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luded studies</a:t>
            </a:r>
            <a:endParaRPr kumimoji="1"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B77C9645-1D94-6147-82A8-903EE312DA44}"/>
              </a:ext>
            </a:extLst>
          </p:cNvPr>
          <p:cNvSpPr txBox="1"/>
          <p:nvPr/>
        </p:nvSpPr>
        <p:spPr>
          <a:xfrm>
            <a:off x="7563849" y="2253752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600" dirty="0">
                <a:solidFill>
                  <a:schemeClr val="bg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·</a:t>
            </a:r>
            <a:endParaRPr kumimoji="1" lang="zh-CN" altLang="en-US" sz="1600" dirty="0">
              <a:solidFill>
                <a:schemeClr val="bg2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9F4DF4DD-0AAA-5A42-A32A-B251A738DF27}"/>
              </a:ext>
            </a:extLst>
          </p:cNvPr>
          <p:cNvSpPr txBox="1"/>
          <p:nvPr/>
        </p:nvSpPr>
        <p:spPr>
          <a:xfrm>
            <a:off x="6332882" y="2262598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600" dirty="0">
                <a:solidFill>
                  <a:schemeClr val="bg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·</a:t>
            </a:r>
            <a:endParaRPr kumimoji="1" lang="zh-CN" altLang="en-US" sz="1600" dirty="0">
              <a:solidFill>
                <a:schemeClr val="bg2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矩形 59">
            <a:extLst>
              <a:ext uri="{FF2B5EF4-FFF2-40B4-BE49-F238E27FC236}">
                <a16:creationId xmlns:a16="http://schemas.microsoft.com/office/drawing/2014/main" id="{C10EE0A8-BB99-D247-B3E4-7AF6301557B9}"/>
              </a:ext>
            </a:extLst>
          </p:cNvPr>
          <p:cNvSpPr/>
          <p:nvPr/>
        </p:nvSpPr>
        <p:spPr>
          <a:xfrm>
            <a:off x="3382616" y="626165"/>
            <a:ext cx="5456583" cy="492950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BFF10B6E-9DB7-9C4B-84D2-29DE5F0F64C4}"/>
              </a:ext>
            </a:extLst>
          </p:cNvPr>
          <p:cNvSpPr txBox="1"/>
          <p:nvPr/>
        </p:nvSpPr>
        <p:spPr>
          <a:xfrm>
            <a:off x="3597440" y="5793297"/>
            <a:ext cx="498868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Contribution graph of %degradation; A: BM, B: MAO-coated Mg, C: FLU-coated Mg , D: 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Ca-P-coated Mg.</a:t>
            </a:r>
            <a:endParaRPr lang="zh-CN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72876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椭圆 66">
            <a:extLst>
              <a:ext uri="{FF2B5EF4-FFF2-40B4-BE49-F238E27FC236}">
                <a16:creationId xmlns:a16="http://schemas.microsoft.com/office/drawing/2014/main" id="{DCCCF4DC-0114-3C41-BE61-A03C4DD1C765}"/>
              </a:ext>
            </a:extLst>
          </p:cNvPr>
          <p:cNvSpPr/>
          <p:nvPr/>
        </p:nvSpPr>
        <p:spPr>
          <a:xfrm>
            <a:off x="6119833" y="4599584"/>
            <a:ext cx="196287" cy="200650"/>
          </a:xfrm>
          <a:prstGeom prst="ellipse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椭圆 90">
            <a:extLst>
              <a:ext uri="{FF2B5EF4-FFF2-40B4-BE49-F238E27FC236}">
                <a16:creationId xmlns:a16="http://schemas.microsoft.com/office/drawing/2014/main" id="{76D4A757-3004-8C43-8D7C-45EE0466AAC6}"/>
              </a:ext>
            </a:extLst>
          </p:cNvPr>
          <p:cNvSpPr/>
          <p:nvPr/>
        </p:nvSpPr>
        <p:spPr>
          <a:xfrm>
            <a:off x="7906366" y="4616252"/>
            <a:ext cx="197887" cy="198000"/>
          </a:xfrm>
          <a:prstGeom prst="ellipse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椭圆 86">
            <a:extLst>
              <a:ext uri="{FF2B5EF4-FFF2-40B4-BE49-F238E27FC236}">
                <a16:creationId xmlns:a16="http://schemas.microsoft.com/office/drawing/2014/main" id="{47CDA36C-B045-0345-8F33-3D271BE60CF7}"/>
              </a:ext>
            </a:extLst>
          </p:cNvPr>
          <p:cNvSpPr/>
          <p:nvPr/>
        </p:nvSpPr>
        <p:spPr>
          <a:xfrm>
            <a:off x="7291584" y="4598045"/>
            <a:ext cx="234000" cy="234000"/>
          </a:xfrm>
          <a:prstGeom prst="ellipse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矩形 43">
            <a:extLst>
              <a:ext uri="{FF2B5EF4-FFF2-40B4-BE49-F238E27FC236}">
                <a16:creationId xmlns:a16="http://schemas.microsoft.com/office/drawing/2014/main" id="{CFF3F092-9C14-004B-9E78-24002F7CFAB0}"/>
              </a:ext>
            </a:extLst>
          </p:cNvPr>
          <p:cNvSpPr/>
          <p:nvPr/>
        </p:nvSpPr>
        <p:spPr>
          <a:xfrm>
            <a:off x="5850665" y="5027869"/>
            <a:ext cx="236475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9      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4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矩形 54">
            <a:extLst>
              <a:ext uri="{FF2B5EF4-FFF2-40B4-BE49-F238E27FC236}">
                <a16:creationId xmlns:a16="http://schemas.microsoft.com/office/drawing/2014/main" id="{B13F5518-C22A-ED4A-AD06-3E6FC6BC4114}"/>
              </a:ext>
            </a:extLst>
          </p:cNvPr>
          <p:cNvSpPr/>
          <p:nvPr/>
        </p:nvSpPr>
        <p:spPr>
          <a:xfrm>
            <a:off x="5849495" y="4580008"/>
            <a:ext cx="242887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.9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5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6.9       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29.6</a:t>
            </a:r>
          </a:p>
        </p:txBody>
      </p:sp>
      <p:sp>
        <p:nvSpPr>
          <p:cNvPr id="84" name="椭圆 83">
            <a:extLst>
              <a:ext uri="{FF2B5EF4-FFF2-40B4-BE49-F238E27FC236}">
                <a16:creationId xmlns:a16="http://schemas.microsoft.com/office/drawing/2014/main" id="{D5958B7B-2942-3744-ADDA-6B945DF93CE9}"/>
              </a:ext>
            </a:extLst>
          </p:cNvPr>
          <p:cNvSpPr/>
          <p:nvPr/>
        </p:nvSpPr>
        <p:spPr>
          <a:xfrm>
            <a:off x="6792135" y="4668897"/>
            <a:ext cx="43200" cy="43200"/>
          </a:xfrm>
          <a:prstGeom prst="ellipse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椭圆 63">
            <a:extLst>
              <a:ext uri="{FF2B5EF4-FFF2-40B4-BE49-F238E27FC236}">
                <a16:creationId xmlns:a16="http://schemas.microsoft.com/office/drawing/2014/main" id="{3D094DC7-C0FC-7A45-BC58-A746F64D8B86}"/>
              </a:ext>
            </a:extLst>
          </p:cNvPr>
          <p:cNvSpPr/>
          <p:nvPr/>
        </p:nvSpPr>
        <p:spPr>
          <a:xfrm>
            <a:off x="7128312" y="2414192"/>
            <a:ext cx="540000" cy="538780"/>
          </a:xfrm>
          <a:prstGeom prst="ellipse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椭圆 71">
            <a:extLst>
              <a:ext uri="{FF2B5EF4-FFF2-40B4-BE49-F238E27FC236}">
                <a16:creationId xmlns:a16="http://schemas.microsoft.com/office/drawing/2014/main" id="{F3D83125-349F-744A-9DCD-47C63438CA39}"/>
              </a:ext>
            </a:extLst>
          </p:cNvPr>
          <p:cNvSpPr/>
          <p:nvPr/>
        </p:nvSpPr>
        <p:spPr>
          <a:xfrm>
            <a:off x="7242297" y="2211584"/>
            <a:ext cx="314291" cy="290798"/>
          </a:xfrm>
          <a:prstGeom prst="ellipse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椭圆 74">
            <a:extLst>
              <a:ext uri="{FF2B5EF4-FFF2-40B4-BE49-F238E27FC236}">
                <a16:creationId xmlns:a16="http://schemas.microsoft.com/office/drawing/2014/main" id="{105828D8-AD9C-244D-9392-F8D75383CBC1}"/>
              </a:ext>
            </a:extLst>
          </p:cNvPr>
          <p:cNvSpPr/>
          <p:nvPr/>
        </p:nvSpPr>
        <p:spPr>
          <a:xfrm>
            <a:off x="7374982" y="2984893"/>
            <a:ext cx="36000" cy="36000"/>
          </a:xfrm>
          <a:prstGeom prst="ellipse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椭圆 84">
            <a:extLst>
              <a:ext uri="{FF2B5EF4-FFF2-40B4-BE49-F238E27FC236}">
                <a16:creationId xmlns:a16="http://schemas.microsoft.com/office/drawing/2014/main" id="{3FDE725D-D84C-6B46-B0CB-41069DAA7302}"/>
              </a:ext>
            </a:extLst>
          </p:cNvPr>
          <p:cNvSpPr/>
          <p:nvPr/>
        </p:nvSpPr>
        <p:spPr>
          <a:xfrm>
            <a:off x="7383457" y="2024283"/>
            <a:ext cx="28800" cy="28800"/>
          </a:xfrm>
          <a:prstGeom prst="ellipse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椭圆 85">
            <a:extLst>
              <a:ext uri="{FF2B5EF4-FFF2-40B4-BE49-F238E27FC236}">
                <a16:creationId xmlns:a16="http://schemas.microsoft.com/office/drawing/2014/main" id="{F41A6779-C5D6-AA4D-979E-5B7C52BD94F6}"/>
              </a:ext>
            </a:extLst>
          </p:cNvPr>
          <p:cNvSpPr/>
          <p:nvPr/>
        </p:nvSpPr>
        <p:spPr>
          <a:xfrm>
            <a:off x="7301274" y="3636944"/>
            <a:ext cx="216000" cy="216000"/>
          </a:xfrm>
          <a:prstGeom prst="ellipse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椭圆 87">
            <a:extLst>
              <a:ext uri="{FF2B5EF4-FFF2-40B4-BE49-F238E27FC236}">
                <a16:creationId xmlns:a16="http://schemas.microsoft.com/office/drawing/2014/main" id="{CA6A026F-D0DC-9640-A518-4421E73EA955}"/>
              </a:ext>
            </a:extLst>
          </p:cNvPr>
          <p:cNvSpPr/>
          <p:nvPr/>
        </p:nvSpPr>
        <p:spPr>
          <a:xfrm>
            <a:off x="7266840" y="3928390"/>
            <a:ext cx="288000" cy="288000"/>
          </a:xfrm>
          <a:prstGeom prst="ellipse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椭圆 6">
            <a:extLst>
              <a:ext uri="{FF2B5EF4-FFF2-40B4-BE49-F238E27FC236}">
                <a16:creationId xmlns:a16="http://schemas.microsoft.com/office/drawing/2014/main" id="{84C44E4D-2E74-4E45-9879-82A4691B25C2}"/>
              </a:ext>
            </a:extLst>
          </p:cNvPr>
          <p:cNvSpPr/>
          <p:nvPr/>
        </p:nvSpPr>
        <p:spPr>
          <a:xfrm>
            <a:off x="5915437" y="1764960"/>
            <a:ext cx="603796" cy="608141"/>
          </a:xfrm>
          <a:prstGeom prst="ellipse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椭圆 64">
            <a:extLst>
              <a:ext uri="{FF2B5EF4-FFF2-40B4-BE49-F238E27FC236}">
                <a16:creationId xmlns:a16="http://schemas.microsoft.com/office/drawing/2014/main" id="{AFCD4895-FAB5-644D-B5E2-AA26952A6E86}"/>
              </a:ext>
            </a:extLst>
          </p:cNvPr>
          <p:cNvSpPr/>
          <p:nvPr/>
        </p:nvSpPr>
        <p:spPr>
          <a:xfrm>
            <a:off x="6107133" y="3667484"/>
            <a:ext cx="220403" cy="229851"/>
          </a:xfrm>
          <a:prstGeom prst="ellipse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椭圆 65">
            <a:extLst>
              <a:ext uri="{FF2B5EF4-FFF2-40B4-BE49-F238E27FC236}">
                <a16:creationId xmlns:a16="http://schemas.microsoft.com/office/drawing/2014/main" id="{AD3D93E4-F0BA-0E4D-BB8F-A61DE4DE3B48}"/>
              </a:ext>
            </a:extLst>
          </p:cNvPr>
          <p:cNvSpPr/>
          <p:nvPr/>
        </p:nvSpPr>
        <p:spPr>
          <a:xfrm>
            <a:off x="6064930" y="3902529"/>
            <a:ext cx="298450" cy="306054"/>
          </a:xfrm>
          <a:prstGeom prst="ellipse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椭圆 72">
            <a:extLst>
              <a:ext uri="{FF2B5EF4-FFF2-40B4-BE49-F238E27FC236}">
                <a16:creationId xmlns:a16="http://schemas.microsoft.com/office/drawing/2014/main" id="{8D85861A-ED92-1D42-8287-BAC0D55D8B0B}"/>
              </a:ext>
            </a:extLst>
          </p:cNvPr>
          <p:cNvSpPr/>
          <p:nvPr/>
        </p:nvSpPr>
        <p:spPr>
          <a:xfrm>
            <a:off x="7827617" y="2226862"/>
            <a:ext cx="314291" cy="290798"/>
          </a:xfrm>
          <a:prstGeom prst="ellipse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椭圆 78">
            <a:extLst>
              <a:ext uri="{FF2B5EF4-FFF2-40B4-BE49-F238E27FC236}">
                <a16:creationId xmlns:a16="http://schemas.microsoft.com/office/drawing/2014/main" id="{728329F7-96F2-3C43-93EF-149289B0ABCA}"/>
              </a:ext>
            </a:extLst>
          </p:cNvPr>
          <p:cNvSpPr/>
          <p:nvPr/>
        </p:nvSpPr>
        <p:spPr>
          <a:xfrm>
            <a:off x="6808332" y="2336618"/>
            <a:ext cx="45719" cy="47679"/>
          </a:xfrm>
          <a:prstGeom prst="ellipse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椭圆 79">
            <a:extLst>
              <a:ext uri="{FF2B5EF4-FFF2-40B4-BE49-F238E27FC236}">
                <a16:creationId xmlns:a16="http://schemas.microsoft.com/office/drawing/2014/main" id="{9EB08F8F-A517-ED4B-9425-59486A244895}"/>
              </a:ext>
            </a:extLst>
          </p:cNvPr>
          <p:cNvSpPr/>
          <p:nvPr/>
        </p:nvSpPr>
        <p:spPr>
          <a:xfrm>
            <a:off x="6802245" y="2625983"/>
            <a:ext cx="55231" cy="57599"/>
          </a:xfrm>
          <a:prstGeom prst="ellipse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椭圆 80">
            <a:extLst>
              <a:ext uri="{FF2B5EF4-FFF2-40B4-BE49-F238E27FC236}">
                <a16:creationId xmlns:a16="http://schemas.microsoft.com/office/drawing/2014/main" id="{8CEC64D9-507A-354C-9715-2D49F5311EAA}"/>
              </a:ext>
            </a:extLst>
          </p:cNvPr>
          <p:cNvSpPr/>
          <p:nvPr/>
        </p:nvSpPr>
        <p:spPr>
          <a:xfrm>
            <a:off x="6808435" y="2921849"/>
            <a:ext cx="36000" cy="36000"/>
          </a:xfrm>
          <a:prstGeom prst="ellipse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椭圆 81">
            <a:extLst>
              <a:ext uri="{FF2B5EF4-FFF2-40B4-BE49-F238E27FC236}">
                <a16:creationId xmlns:a16="http://schemas.microsoft.com/office/drawing/2014/main" id="{E534F103-B497-DA4F-A671-23182BC6D0EF}"/>
              </a:ext>
            </a:extLst>
          </p:cNvPr>
          <p:cNvSpPr/>
          <p:nvPr/>
        </p:nvSpPr>
        <p:spPr>
          <a:xfrm>
            <a:off x="6794962" y="3754852"/>
            <a:ext cx="43200" cy="43200"/>
          </a:xfrm>
          <a:prstGeom prst="ellipse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椭圆 82">
            <a:extLst>
              <a:ext uri="{FF2B5EF4-FFF2-40B4-BE49-F238E27FC236}">
                <a16:creationId xmlns:a16="http://schemas.microsoft.com/office/drawing/2014/main" id="{D9C71E28-29FA-EA49-8B4B-01CBEEFBE278}"/>
              </a:ext>
            </a:extLst>
          </p:cNvPr>
          <p:cNvSpPr/>
          <p:nvPr/>
        </p:nvSpPr>
        <p:spPr>
          <a:xfrm>
            <a:off x="6794885" y="4038936"/>
            <a:ext cx="43200" cy="43200"/>
          </a:xfrm>
          <a:prstGeom prst="ellipse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椭圆 88">
            <a:extLst>
              <a:ext uri="{FF2B5EF4-FFF2-40B4-BE49-F238E27FC236}">
                <a16:creationId xmlns:a16="http://schemas.microsoft.com/office/drawing/2014/main" id="{B631D140-AA02-3F42-8329-62B454548BF5}"/>
              </a:ext>
            </a:extLst>
          </p:cNvPr>
          <p:cNvSpPr/>
          <p:nvPr/>
        </p:nvSpPr>
        <p:spPr>
          <a:xfrm>
            <a:off x="7670061" y="2633858"/>
            <a:ext cx="596227" cy="597600"/>
          </a:xfrm>
          <a:prstGeom prst="ellipse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椭圆 89">
            <a:extLst>
              <a:ext uri="{FF2B5EF4-FFF2-40B4-BE49-F238E27FC236}">
                <a16:creationId xmlns:a16="http://schemas.microsoft.com/office/drawing/2014/main" id="{00081BE0-AD6D-6C49-8CAD-CC5BE4F0EDE0}"/>
              </a:ext>
            </a:extLst>
          </p:cNvPr>
          <p:cNvSpPr/>
          <p:nvPr/>
        </p:nvSpPr>
        <p:spPr>
          <a:xfrm>
            <a:off x="7888046" y="3667484"/>
            <a:ext cx="212400" cy="213084"/>
          </a:xfrm>
          <a:prstGeom prst="ellipse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椭圆 91">
            <a:extLst>
              <a:ext uri="{FF2B5EF4-FFF2-40B4-BE49-F238E27FC236}">
                <a16:creationId xmlns:a16="http://schemas.microsoft.com/office/drawing/2014/main" id="{1A25AEF4-DE01-4540-9189-1928FF96C59B}"/>
              </a:ext>
            </a:extLst>
          </p:cNvPr>
          <p:cNvSpPr/>
          <p:nvPr/>
        </p:nvSpPr>
        <p:spPr>
          <a:xfrm>
            <a:off x="7979059" y="4051404"/>
            <a:ext cx="46800" cy="46800"/>
          </a:xfrm>
          <a:prstGeom prst="ellipse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椭圆 92">
            <a:extLst>
              <a:ext uri="{FF2B5EF4-FFF2-40B4-BE49-F238E27FC236}">
                <a16:creationId xmlns:a16="http://schemas.microsoft.com/office/drawing/2014/main" id="{652DCAD2-A764-1643-8248-E2F0D8048E7E}"/>
              </a:ext>
            </a:extLst>
          </p:cNvPr>
          <p:cNvSpPr/>
          <p:nvPr/>
        </p:nvSpPr>
        <p:spPr>
          <a:xfrm>
            <a:off x="7946883" y="2632891"/>
            <a:ext cx="61200" cy="61200"/>
          </a:xfrm>
          <a:prstGeom prst="ellipse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椭圆 93">
            <a:extLst>
              <a:ext uri="{FF2B5EF4-FFF2-40B4-BE49-F238E27FC236}">
                <a16:creationId xmlns:a16="http://schemas.microsoft.com/office/drawing/2014/main" id="{2600682A-E465-7B4F-BDA3-9FE730B7421E}"/>
              </a:ext>
            </a:extLst>
          </p:cNvPr>
          <p:cNvSpPr/>
          <p:nvPr/>
        </p:nvSpPr>
        <p:spPr>
          <a:xfrm flipV="1">
            <a:off x="7984763" y="2066643"/>
            <a:ext cx="3600" cy="3600"/>
          </a:xfrm>
          <a:prstGeom prst="ellipse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6F71F877-6B13-084D-88AD-A5A7B70F75A1}"/>
              </a:ext>
            </a:extLst>
          </p:cNvPr>
          <p:cNvSpPr txBox="1"/>
          <p:nvPr/>
        </p:nvSpPr>
        <p:spPr>
          <a:xfrm>
            <a:off x="5884304" y="762839"/>
            <a:ext cx="24880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rect comparisons in the network</a:t>
            </a:r>
            <a:endParaRPr kumimoji="1"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直线连接符 19">
            <a:extLst>
              <a:ext uri="{FF2B5EF4-FFF2-40B4-BE49-F238E27FC236}">
                <a16:creationId xmlns:a16="http://schemas.microsoft.com/office/drawing/2014/main" id="{7727FD59-46C7-5841-B5ED-34B8A959F945}"/>
              </a:ext>
            </a:extLst>
          </p:cNvPr>
          <p:cNvCxnSpPr>
            <a:cxnSpLocks/>
          </p:cNvCxnSpPr>
          <p:nvPr/>
        </p:nvCxnSpPr>
        <p:spPr>
          <a:xfrm>
            <a:off x="5509081" y="704249"/>
            <a:ext cx="0" cy="458680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52FE4A5F-496E-1B44-9A3D-CEDA79E94312}"/>
              </a:ext>
            </a:extLst>
          </p:cNvPr>
          <p:cNvSpPr txBox="1"/>
          <p:nvPr/>
        </p:nvSpPr>
        <p:spPr>
          <a:xfrm>
            <a:off x="4018425" y="4505950"/>
            <a:ext cx="1136850" cy="3411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tire network</a:t>
            </a: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00B8E60F-AD65-6648-B564-028A6250FC05}"/>
              </a:ext>
            </a:extLst>
          </p:cNvPr>
          <p:cNvSpPr txBox="1"/>
          <p:nvPr/>
        </p:nvSpPr>
        <p:spPr>
          <a:xfrm>
            <a:off x="4139027" y="3300871"/>
            <a:ext cx="11769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rect estimates</a:t>
            </a:r>
            <a:endParaRPr kumimoji="1"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3528AA92-7030-B04F-A58D-FE9C05A7702D}"/>
              </a:ext>
            </a:extLst>
          </p:cNvPr>
          <p:cNvSpPr/>
          <p:nvPr/>
        </p:nvSpPr>
        <p:spPr>
          <a:xfrm>
            <a:off x="4144557" y="1690200"/>
            <a:ext cx="110799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xed estimates</a:t>
            </a: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39C3B1B8-2F2B-254B-9198-3EDC0D0A840A}"/>
              </a:ext>
            </a:extLst>
          </p:cNvPr>
          <p:cNvSpPr txBox="1"/>
          <p:nvPr/>
        </p:nvSpPr>
        <p:spPr>
          <a:xfrm rot="16200000">
            <a:off x="2662182" y="2763345"/>
            <a:ext cx="22252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twork</a:t>
            </a:r>
            <a:r>
              <a:rPr kumimoji="1"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-analysis</a:t>
            </a:r>
            <a:r>
              <a:rPr kumimoji="1"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timates</a:t>
            </a:r>
            <a:endParaRPr kumimoji="1"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9B8D346D-09AB-774A-9C51-623CB6E6905B}"/>
              </a:ext>
            </a:extLst>
          </p:cNvPr>
          <p:cNvSpPr/>
          <p:nvPr/>
        </p:nvSpPr>
        <p:spPr>
          <a:xfrm>
            <a:off x="4940527" y="1956476"/>
            <a:ext cx="337613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1"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vsB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9.2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8F553B5A-BE2A-A744-BB56-4A6E5C08883A}"/>
              </a:ext>
            </a:extLst>
          </p:cNvPr>
          <p:cNvSpPr/>
          <p:nvPr/>
        </p:nvSpPr>
        <p:spPr>
          <a:xfrm>
            <a:off x="6006415" y="1090524"/>
            <a:ext cx="231024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vsB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</a:t>
            </a:r>
            <a:r>
              <a:rPr kumimoji="1"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vsC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</a:t>
            </a:r>
            <a:r>
              <a:rPr kumimoji="1"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vsD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</a:t>
            </a:r>
            <a:r>
              <a:rPr kumimoji="1"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vsD</a:t>
            </a:r>
            <a:endParaRPr kumimoji="1"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线连接符 35">
            <a:extLst>
              <a:ext uri="{FF2B5EF4-FFF2-40B4-BE49-F238E27FC236}">
                <a16:creationId xmlns:a16="http://schemas.microsoft.com/office/drawing/2014/main" id="{81D98614-3AC6-7246-9B05-840F7B319EEF}"/>
              </a:ext>
            </a:extLst>
          </p:cNvPr>
          <p:cNvCxnSpPr>
            <a:cxnSpLocks/>
          </p:cNvCxnSpPr>
          <p:nvPr/>
        </p:nvCxnSpPr>
        <p:spPr>
          <a:xfrm>
            <a:off x="3946505" y="3171451"/>
            <a:ext cx="4170886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4" name="组合 53">
            <a:extLst>
              <a:ext uri="{FF2B5EF4-FFF2-40B4-BE49-F238E27FC236}">
                <a16:creationId xmlns:a16="http://schemas.microsoft.com/office/drawing/2014/main" id="{4A10111D-096E-DA40-8154-349A58B307ED}"/>
              </a:ext>
            </a:extLst>
          </p:cNvPr>
          <p:cNvGrpSpPr/>
          <p:nvPr/>
        </p:nvGrpSpPr>
        <p:grpSpPr>
          <a:xfrm>
            <a:off x="3619681" y="1496481"/>
            <a:ext cx="4917437" cy="3445946"/>
            <a:chOff x="3333404" y="1571105"/>
            <a:chExt cx="5002219" cy="3445946"/>
          </a:xfrm>
        </p:grpSpPr>
        <p:cxnSp>
          <p:nvCxnSpPr>
            <p:cNvPr id="22" name="直线连接符 21">
              <a:extLst>
                <a:ext uri="{FF2B5EF4-FFF2-40B4-BE49-F238E27FC236}">
                  <a16:creationId xmlns:a16="http://schemas.microsoft.com/office/drawing/2014/main" id="{67399949-CC41-3441-AB92-66AF782ACE99}"/>
                </a:ext>
              </a:extLst>
            </p:cNvPr>
            <p:cNvCxnSpPr>
              <a:cxnSpLocks/>
            </p:cNvCxnSpPr>
            <p:nvPr/>
          </p:nvCxnSpPr>
          <p:spPr>
            <a:xfrm>
              <a:off x="3333404" y="1571105"/>
              <a:ext cx="500221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" name="直线连接符 47">
              <a:extLst>
                <a:ext uri="{FF2B5EF4-FFF2-40B4-BE49-F238E27FC236}">
                  <a16:creationId xmlns:a16="http://schemas.microsoft.com/office/drawing/2014/main" id="{151E70A3-7832-2D4B-AF6C-D64D0DF9D48C}"/>
                </a:ext>
              </a:extLst>
            </p:cNvPr>
            <p:cNvCxnSpPr>
              <a:cxnSpLocks/>
            </p:cNvCxnSpPr>
            <p:nvPr/>
          </p:nvCxnSpPr>
          <p:spPr>
            <a:xfrm>
              <a:off x="3348155" y="4508269"/>
              <a:ext cx="479228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9" name="直线连接符 48">
              <a:extLst>
                <a:ext uri="{FF2B5EF4-FFF2-40B4-BE49-F238E27FC236}">
                  <a16:creationId xmlns:a16="http://schemas.microsoft.com/office/drawing/2014/main" id="{1A019ED1-C963-7A4C-BAE5-EED160F6BBDA}"/>
                </a:ext>
              </a:extLst>
            </p:cNvPr>
            <p:cNvCxnSpPr>
              <a:cxnSpLocks/>
            </p:cNvCxnSpPr>
            <p:nvPr/>
          </p:nvCxnSpPr>
          <p:spPr>
            <a:xfrm>
              <a:off x="3348154" y="5017051"/>
              <a:ext cx="479228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0" name="矩形 49">
            <a:extLst>
              <a:ext uri="{FF2B5EF4-FFF2-40B4-BE49-F238E27FC236}">
                <a16:creationId xmlns:a16="http://schemas.microsoft.com/office/drawing/2014/main" id="{C72509A2-B375-BA4C-B0F2-CA2EFFEEB468}"/>
              </a:ext>
            </a:extLst>
          </p:cNvPr>
          <p:cNvSpPr/>
          <p:nvPr/>
        </p:nvSpPr>
        <p:spPr>
          <a:xfrm>
            <a:off x="3960717" y="4949567"/>
            <a:ext cx="1191352" cy="3361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luded studies</a:t>
            </a:r>
            <a:endParaRPr kumimoji="1"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矩形 59">
            <a:extLst>
              <a:ext uri="{FF2B5EF4-FFF2-40B4-BE49-F238E27FC236}">
                <a16:creationId xmlns:a16="http://schemas.microsoft.com/office/drawing/2014/main" id="{C10EE0A8-BB99-D247-B3E4-7AF6301557B9}"/>
              </a:ext>
            </a:extLst>
          </p:cNvPr>
          <p:cNvSpPr/>
          <p:nvPr/>
        </p:nvSpPr>
        <p:spPr>
          <a:xfrm>
            <a:off x="2898826" y="551541"/>
            <a:ext cx="6394348" cy="492950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BFF10B6E-9DB7-9C4B-84D2-29DE5F0F64C4}"/>
              </a:ext>
            </a:extLst>
          </p:cNvPr>
          <p:cNvSpPr txBox="1"/>
          <p:nvPr/>
        </p:nvSpPr>
        <p:spPr>
          <a:xfrm>
            <a:off x="3218059" y="5727270"/>
            <a:ext cx="577814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Contribution graph of new bone formation; A: BM, B: MAO-coated Mg, C: FLU-coated Mg , D: Ca-P-coated Mg.</a:t>
            </a:r>
            <a:endParaRPr lang="zh-CN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矩形 45">
            <a:extLst>
              <a:ext uri="{FF2B5EF4-FFF2-40B4-BE49-F238E27FC236}">
                <a16:creationId xmlns:a16="http://schemas.microsoft.com/office/drawing/2014/main" id="{9A350DD0-F255-9340-924B-B23F5637E183}"/>
              </a:ext>
            </a:extLst>
          </p:cNvPr>
          <p:cNvSpPr/>
          <p:nvPr/>
        </p:nvSpPr>
        <p:spPr>
          <a:xfrm>
            <a:off x="4940527" y="2235247"/>
            <a:ext cx="337613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1"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vsC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8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7.6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7.6</a:t>
            </a:r>
          </a:p>
        </p:txBody>
      </p:sp>
      <p:sp>
        <p:nvSpPr>
          <p:cNvPr id="47" name="矩形 46">
            <a:extLst>
              <a:ext uri="{FF2B5EF4-FFF2-40B4-BE49-F238E27FC236}">
                <a16:creationId xmlns:a16="http://schemas.microsoft.com/office/drawing/2014/main" id="{58B41906-A117-3144-8A02-046673AD901D}"/>
              </a:ext>
            </a:extLst>
          </p:cNvPr>
          <p:cNvSpPr/>
          <p:nvPr/>
        </p:nvSpPr>
        <p:spPr>
          <a:xfrm>
            <a:off x="4940527" y="2533935"/>
            <a:ext cx="337613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1"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vsC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.9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6.1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.0</a:t>
            </a:r>
          </a:p>
        </p:txBody>
      </p:sp>
      <p:sp>
        <p:nvSpPr>
          <p:cNvPr id="51" name="矩形 50">
            <a:extLst>
              <a:ext uri="{FF2B5EF4-FFF2-40B4-BE49-F238E27FC236}">
                <a16:creationId xmlns:a16="http://schemas.microsoft.com/office/drawing/2014/main" id="{49DAC83C-A862-8B41-86B7-7D135CA9DC70}"/>
              </a:ext>
            </a:extLst>
          </p:cNvPr>
          <p:cNvSpPr/>
          <p:nvPr/>
        </p:nvSpPr>
        <p:spPr>
          <a:xfrm>
            <a:off x="4938282" y="2811268"/>
            <a:ext cx="337613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1"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vsD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6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6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6.7</a:t>
            </a:r>
          </a:p>
        </p:txBody>
      </p:sp>
      <p:sp>
        <p:nvSpPr>
          <p:cNvPr id="52" name="矩形 51">
            <a:extLst>
              <a:ext uri="{FF2B5EF4-FFF2-40B4-BE49-F238E27FC236}">
                <a16:creationId xmlns:a16="http://schemas.microsoft.com/office/drawing/2014/main" id="{1F380D61-4F81-EA49-A801-F475F1E9EAC3}"/>
              </a:ext>
            </a:extLst>
          </p:cNvPr>
          <p:cNvSpPr/>
          <p:nvPr/>
        </p:nvSpPr>
        <p:spPr>
          <a:xfrm>
            <a:off x="4931409" y="3656308"/>
            <a:ext cx="337613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1"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vsC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.3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1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1.2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1.3</a:t>
            </a:r>
          </a:p>
        </p:txBody>
      </p:sp>
      <p:sp>
        <p:nvSpPr>
          <p:cNvPr id="53" name="矩形 52">
            <a:extLst>
              <a:ext uri="{FF2B5EF4-FFF2-40B4-BE49-F238E27FC236}">
                <a16:creationId xmlns:a16="http://schemas.microsoft.com/office/drawing/2014/main" id="{9FF3B56F-E863-9F4E-8597-CEEB237F2225}"/>
              </a:ext>
            </a:extLst>
          </p:cNvPr>
          <p:cNvSpPr/>
          <p:nvPr/>
        </p:nvSpPr>
        <p:spPr>
          <a:xfrm>
            <a:off x="4931409" y="3935079"/>
            <a:ext cx="337613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1"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vsD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.1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6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4.5</a:t>
            </a:r>
            <a:r>
              <a:rPr kumimoji="1"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</a:t>
            </a:r>
            <a:r>
              <a:rPr kumimoji="1"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7</a:t>
            </a:r>
          </a:p>
        </p:txBody>
      </p:sp>
    </p:spTree>
    <p:extLst>
      <p:ext uri="{BB962C8B-B14F-4D97-AF65-F5344CB8AC3E}">
        <p14:creationId xmlns:p14="http://schemas.microsoft.com/office/powerpoint/2010/main" val="27705116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1</TotalTime>
  <Words>188</Words>
  <Application>Microsoft Office PowerPoint</Application>
  <PresentationFormat>宽屏</PresentationFormat>
  <Paragraphs>37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u XinYue</dc:creator>
  <cp:lastModifiedBy>VIP</cp:lastModifiedBy>
  <cp:revision>5</cp:revision>
  <dcterms:created xsi:type="dcterms:W3CDTF">2022-02-19T12:19:12Z</dcterms:created>
  <dcterms:modified xsi:type="dcterms:W3CDTF">2022-02-19T18:20:29Z</dcterms:modified>
</cp:coreProperties>
</file>